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50"/>
  </p:normalViewPr>
  <p:slideViewPr>
    <p:cSldViewPr snapToGrid="0">
      <p:cViewPr>
        <p:scale>
          <a:sx n="44" d="100"/>
          <a:sy n="44" d="100"/>
        </p:scale>
        <p:origin x="1896" y="17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1D80B4-CBF2-85F3-755D-FD742F6F3D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3A6D04B-466A-2847-38FD-E34BE1844E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875E12-4B61-32D9-D1DE-C121CED43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B45B28-DC96-4F4B-DC8E-D4C490295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BC304B-C0F4-1141-9347-0A66CC9C3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397806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94ED11-250A-D7A4-A496-77BA4C46FC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F04C4E-378C-7015-F186-39475C507B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9CB12D-6BF9-0E6B-FE6E-C69E4B2B7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821F86-B2F2-5D0E-40B7-426231719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FEFEEB-7312-5A42-3D52-91176CDF9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002881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86DD28-D5FF-B469-264F-8D18DC9EA7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50FD5A-1B1B-A4A0-7730-26908BB356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7FEA49-AD2C-7F16-6BDC-52A49AB07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3460E6-57A4-1287-F32E-4DD55F33A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61277D-85E5-63DF-6685-673DEF707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801197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8515B9-7AB9-622E-D953-C2D8CDC306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D7DDFA-3DBF-463A-20BF-99BD39F584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5F2F47-6A19-E85E-EAC4-79D6B0F7C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CEB1D3-11E7-2AFF-9817-9927B4B94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601938-BBBF-199F-F0E7-24AC7C2A4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422962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824771-2CD5-156E-B638-AA3771A5E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BF4B5C-43BB-19AA-4563-06409699AD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2C8CB0-4E50-566E-0391-D9320E8D2C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3CFA17-D99D-B981-51D8-01F59DF6B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E6302C-0290-0108-13F8-95AB9DC03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267902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374E7-9F7E-6E86-755D-0D9C1EBE1B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F88C7D-5E38-88EF-C9B5-576D82F831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C7849A-5344-419A-FE03-FFEE054490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DE1552-242A-EB94-45FF-C92D7DE1B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83FAD8-EA4F-6A75-0D43-40C2ACB85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E03B5E-A3F0-EFAA-7319-7AF8DFE3C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511949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3BC686-BD99-96D4-EC57-247C9D73EB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54FE7F-44DC-EB84-DDA8-2947735EB8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FAC02E-6EA7-3FDB-248E-0AF790EF66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8A85E7-9E5C-A81A-1898-4373FEB5BE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4B878C-BA30-5150-1BD4-B02597B410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9F65987-F501-D703-AA87-C987BFE71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FF63847-C7EB-269D-FBB8-44761D794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3C7DC9-24EC-2477-1010-EC6AC1807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477306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4B2A1-02FA-9C4F-7F1A-8F217564CE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2D71F42-B7DA-4F4C-9839-E854A07E8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6B4FC17-5187-5949-C7B7-49543E1BE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26B217-59BA-82DD-DEB3-6E41A2112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496322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4AB6A52-6F23-8AD4-DB3F-D98FA1D2E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1A7AD18-6980-D447-70C2-163DD2F89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0EE18B-325D-24A0-B7A0-CA35D543F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849818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F659FC-FA49-1A27-A5E5-5C49E8AF4A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458427-2CED-6951-BDA7-2424378D47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70C310-7D31-DBDF-FA75-291C86BB40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E2407D-7A11-B34D-B276-6CDA30FDE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C1B500-1CFE-E152-4767-F53DCC0AD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635B0D-2002-304A-9067-0804DDCCE5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133936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25DF7-C436-77B1-6DC4-D076949C12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B83493-F56F-9C6C-FB16-F2578A6F53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58717B-4035-60A5-5B8B-394A1B2401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9A33DB-D027-EC19-BDB0-053598C34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301-6455-CF44-9F88-2C75ADA911FA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46D9EC-EBFD-01EB-8C07-61654D4D1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62044C-4E87-0556-603C-B36582195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C4A2-201B-504D-9EC0-D3BCD86C5C49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27557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B8559C-F160-5EB3-6DE4-696214C7C7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DCA5AA-B606-D261-2A56-6F45962381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4A68E0-CA4E-03A5-E9AA-885893AC2E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188301-6455-CF44-9F88-2C75ADA911FA}" type="datetimeFigureOut">
              <a:rPr lang="en-VN" smtClean="0"/>
              <a:t>15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FFBBDA-52B9-F62F-0906-7916652796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84364C-C01E-809A-B20A-D181E786DE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72C4A2-201B-504D-9EC0-D3BCD86C5C49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906240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6B4AFA3-7C6E-D359-ED8D-242671F090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4928" y="1612900"/>
            <a:ext cx="6070600" cy="3835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557402C-8C34-D802-63E9-A71E350640D6}"/>
              </a:ext>
            </a:extLst>
          </p:cNvPr>
          <p:cNvSpPr txBox="1"/>
          <p:nvPr/>
        </p:nvSpPr>
        <p:spPr>
          <a:xfrm>
            <a:off x="348343" y="203199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1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8BD48D-4CFF-00D5-F429-3D9B85A308D6}"/>
              </a:ext>
            </a:extLst>
          </p:cNvPr>
          <p:cNvSpPr txBox="1"/>
          <p:nvPr/>
        </p:nvSpPr>
        <p:spPr>
          <a:xfrm>
            <a:off x="2310407" y="2452914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80kDa</a:t>
            </a:r>
            <a:endParaRPr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9FFE2B3-1034-3E6A-A467-2E352C8C2E20}"/>
              </a:ext>
            </a:extLst>
          </p:cNvPr>
          <p:cNvSpPr txBox="1"/>
          <p:nvPr/>
        </p:nvSpPr>
        <p:spPr>
          <a:xfrm>
            <a:off x="2310407" y="2706131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0kDa</a:t>
            </a:r>
            <a:endParaRPr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825ABBC-EDA0-8B79-8C43-F082037E8F94}"/>
              </a:ext>
            </a:extLst>
          </p:cNvPr>
          <p:cNvSpPr txBox="1"/>
          <p:nvPr/>
        </p:nvSpPr>
        <p:spPr>
          <a:xfrm>
            <a:off x="2310407" y="3059668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kDa</a:t>
            </a:r>
            <a:endParaRPr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006CCD-E98A-97F0-E924-D28BC25182CF}"/>
              </a:ext>
            </a:extLst>
          </p:cNvPr>
          <p:cNvSpPr txBox="1"/>
          <p:nvPr/>
        </p:nvSpPr>
        <p:spPr>
          <a:xfrm>
            <a:off x="2310407" y="3462564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0kDa</a:t>
            </a:r>
            <a:endParaRPr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B69A12-3935-89E5-01CB-823243E97FFA}"/>
              </a:ext>
            </a:extLst>
          </p:cNvPr>
          <p:cNvSpPr txBox="1"/>
          <p:nvPr/>
        </p:nvSpPr>
        <p:spPr>
          <a:xfrm>
            <a:off x="2310406" y="3879583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5kDa</a:t>
            </a:r>
            <a:endParaRPr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DCCD416-4DFC-7541-BB9A-9A839B200453}"/>
              </a:ext>
            </a:extLst>
          </p:cNvPr>
          <p:cNvSpPr txBox="1"/>
          <p:nvPr/>
        </p:nvSpPr>
        <p:spPr>
          <a:xfrm>
            <a:off x="2310406" y="4353450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0kDa</a:t>
            </a:r>
            <a:endParaRPr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B266618-3F14-9283-1E63-3E0FDD880A7F}"/>
              </a:ext>
            </a:extLst>
          </p:cNvPr>
          <p:cNvSpPr txBox="1"/>
          <p:nvPr/>
        </p:nvSpPr>
        <p:spPr>
          <a:xfrm>
            <a:off x="2310405" y="4885373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kDa</a:t>
            </a:r>
            <a:endParaRPr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CD14375-88BE-3C4C-3A22-78E164B848DA}"/>
              </a:ext>
            </a:extLst>
          </p:cNvPr>
          <p:cNvSpPr txBox="1"/>
          <p:nvPr/>
        </p:nvSpPr>
        <p:spPr>
          <a:xfrm>
            <a:off x="2310404" y="5212443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kDa</a:t>
            </a:r>
            <a:endParaRPr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2BD888F-DF4E-8BDE-C5FB-7F0D2150563E}"/>
              </a:ext>
            </a:extLst>
          </p:cNvPr>
          <p:cNvSpPr txBox="1"/>
          <p:nvPr/>
        </p:nvSpPr>
        <p:spPr>
          <a:xfrm>
            <a:off x="3624590" y="1277481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 2 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5CB1AC4-AA38-9D2C-216C-5C50F6A13321}"/>
              </a:ext>
            </a:extLst>
          </p:cNvPr>
          <p:cNvSpPr txBox="1"/>
          <p:nvPr/>
        </p:nvSpPr>
        <p:spPr>
          <a:xfrm>
            <a:off x="2062308" y="1247256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C575C0E-AFB5-8074-937D-7011B758E28C}"/>
              </a:ext>
            </a:extLst>
          </p:cNvPr>
          <p:cNvCxnSpPr>
            <a:cxnSpLocks/>
          </p:cNvCxnSpPr>
          <p:nvPr/>
        </p:nvCxnSpPr>
        <p:spPr>
          <a:xfrm flipV="1">
            <a:off x="3748363" y="1217236"/>
            <a:ext cx="5018561" cy="140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1358C8D-13D2-E2C3-2D87-C2BB694B020E}"/>
              </a:ext>
            </a:extLst>
          </p:cNvPr>
          <p:cNvSpPr txBox="1"/>
          <p:nvPr/>
        </p:nvSpPr>
        <p:spPr>
          <a:xfrm>
            <a:off x="5045916" y="1282285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 2 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1FD07B5-38AC-CD79-060F-69D29696EC47}"/>
              </a:ext>
            </a:extLst>
          </p:cNvPr>
          <p:cNvSpPr txBox="1"/>
          <p:nvPr/>
        </p:nvSpPr>
        <p:spPr>
          <a:xfrm>
            <a:off x="6455656" y="1287901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 1 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3263460-8A57-6422-7BD4-9D2D3AA05BA7}"/>
              </a:ext>
            </a:extLst>
          </p:cNvPr>
          <p:cNvSpPr txBox="1"/>
          <p:nvPr/>
        </p:nvSpPr>
        <p:spPr>
          <a:xfrm>
            <a:off x="7699965" y="1249758"/>
            <a:ext cx="2133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B552853-4B73-0A57-8E12-2EC7B7C0A2CC}"/>
              </a:ext>
            </a:extLst>
          </p:cNvPr>
          <p:cNvSpPr txBox="1"/>
          <p:nvPr/>
        </p:nvSpPr>
        <p:spPr>
          <a:xfrm>
            <a:off x="9224676" y="3589919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ITF-Flag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2FD7867-B74C-5858-7CB2-03433FFB7A1C}"/>
              </a:ext>
            </a:extLst>
          </p:cNvPr>
          <p:cNvSpPr txBox="1"/>
          <p:nvPr/>
        </p:nvSpPr>
        <p:spPr>
          <a:xfrm>
            <a:off x="9224676" y="4350604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0E9463FE-E90C-B9AB-37FE-76E0B7A7764A}"/>
              </a:ext>
            </a:extLst>
          </p:cNvPr>
          <p:cNvSpPr/>
          <p:nvPr/>
        </p:nvSpPr>
        <p:spPr>
          <a:xfrm>
            <a:off x="5045939" y="89055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2742606B-77B0-181C-421B-4BA6A1BC018B}"/>
              </a:ext>
            </a:extLst>
          </p:cNvPr>
          <p:cNvSpPr/>
          <p:nvPr/>
        </p:nvSpPr>
        <p:spPr>
          <a:xfrm>
            <a:off x="6502795" y="896170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1CDE5A40-30CB-3CCC-C88B-0972FDC84969}"/>
              </a:ext>
            </a:extLst>
          </p:cNvPr>
          <p:cNvSpPr/>
          <p:nvPr/>
        </p:nvSpPr>
        <p:spPr>
          <a:xfrm>
            <a:off x="3662023" y="187498"/>
            <a:ext cx="11578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F874F2BA-83AA-7733-DDEF-6478EFE32535}"/>
              </a:ext>
            </a:extLst>
          </p:cNvPr>
          <p:cNvSpPr/>
          <p:nvPr/>
        </p:nvSpPr>
        <p:spPr>
          <a:xfrm>
            <a:off x="2049742" y="847904"/>
            <a:ext cx="17928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21C06F4-1CA2-7C92-A4FD-A4E8368489C7}"/>
              </a:ext>
            </a:extLst>
          </p:cNvPr>
          <p:cNvSpPr txBox="1"/>
          <p:nvPr/>
        </p:nvSpPr>
        <p:spPr>
          <a:xfrm>
            <a:off x="2041797" y="479989"/>
            <a:ext cx="10495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C685F85A-9AD1-3337-C60B-E4E9B12D686A}"/>
              </a:ext>
            </a:extLst>
          </p:cNvPr>
          <p:cNvSpPr/>
          <p:nvPr/>
        </p:nvSpPr>
        <p:spPr>
          <a:xfrm>
            <a:off x="3842626" y="875836"/>
            <a:ext cx="739945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0.1                0.1                1             0.1         (24hours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E3C2869-3CDE-F9CD-53F3-6E18FBF2FFF8}"/>
              </a:ext>
            </a:extLst>
          </p:cNvPr>
          <p:cNvSpPr txBox="1"/>
          <p:nvPr/>
        </p:nvSpPr>
        <p:spPr>
          <a:xfrm>
            <a:off x="4142869" y="564706"/>
            <a:ext cx="68288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WT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EV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7319CF3-5C2F-E1EC-055E-E224A5191BB4}"/>
              </a:ext>
            </a:extLst>
          </p:cNvPr>
          <p:cNvSpPr txBox="1"/>
          <p:nvPr/>
        </p:nvSpPr>
        <p:spPr>
          <a:xfrm>
            <a:off x="7934310" y="1264590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324CE8A4-3725-1C78-A5BE-E2D1B0A8F2B5}"/>
              </a:ext>
            </a:extLst>
          </p:cNvPr>
          <p:cNvSpPr/>
          <p:nvPr/>
        </p:nvSpPr>
        <p:spPr>
          <a:xfrm>
            <a:off x="3501484" y="3451302"/>
            <a:ext cx="4432826" cy="12686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5972EAD2-8221-334E-290A-2FC2BABE0203}"/>
              </a:ext>
            </a:extLst>
          </p:cNvPr>
          <p:cNvSpPr/>
          <p:nvPr/>
        </p:nvSpPr>
        <p:spPr>
          <a:xfrm>
            <a:off x="7888591" y="88258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78063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6560998-666B-6E2B-DE9B-0186C9F0A0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4928" y="1529410"/>
            <a:ext cx="6083300" cy="4064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2A147BF-133E-497C-8084-425384303064}"/>
              </a:ext>
            </a:extLst>
          </p:cNvPr>
          <p:cNvSpPr txBox="1"/>
          <p:nvPr/>
        </p:nvSpPr>
        <p:spPr>
          <a:xfrm>
            <a:off x="348343" y="203199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2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463001-183F-4A35-DB91-18BBAF8FD602}"/>
              </a:ext>
            </a:extLst>
          </p:cNvPr>
          <p:cNvSpPr txBox="1"/>
          <p:nvPr/>
        </p:nvSpPr>
        <p:spPr>
          <a:xfrm>
            <a:off x="2310407" y="2452914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80kDa</a:t>
            </a:r>
            <a:endParaRPr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2857195-02C5-9707-8F6F-4E7C6DAA03A7}"/>
              </a:ext>
            </a:extLst>
          </p:cNvPr>
          <p:cNvSpPr txBox="1"/>
          <p:nvPr/>
        </p:nvSpPr>
        <p:spPr>
          <a:xfrm>
            <a:off x="2310407" y="2706131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0kDa</a:t>
            </a:r>
            <a:endParaRPr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467AC36-D711-AE26-98F0-D300B81D2495}"/>
              </a:ext>
            </a:extLst>
          </p:cNvPr>
          <p:cNvSpPr txBox="1"/>
          <p:nvPr/>
        </p:nvSpPr>
        <p:spPr>
          <a:xfrm>
            <a:off x="2310407" y="3059668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kDa</a:t>
            </a:r>
            <a:endParaRPr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F4ECF3F-61C5-8C3E-2A79-16453648CFED}"/>
              </a:ext>
            </a:extLst>
          </p:cNvPr>
          <p:cNvSpPr txBox="1"/>
          <p:nvPr/>
        </p:nvSpPr>
        <p:spPr>
          <a:xfrm>
            <a:off x="2310407" y="3462564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0kDa</a:t>
            </a:r>
            <a:endParaRPr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342BCA-D913-4353-F991-DCD368116E85}"/>
              </a:ext>
            </a:extLst>
          </p:cNvPr>
          <p:cNvSpPr txBox="1"/>
          <p:nvPr/>
        </p:nvSpPr>
        <p:spPr>
          <a:xfrm>
            <a:off x="2310406" y="3879583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5kDa</a:t>
            </a:r>
            <a:endParaRPr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6517015-FAFC-2451-2E8E-E8CA14336A8E}"/>
              </a:ext>
            </a:extLst>
          </p:cNvPr>
          <p:cNvSpPr txBox="1"/>
          <p:nvPr/>
        </p:nvSpPr>
        <p:spPr>
          <a:xfrm>
            <a:off x="2310406" y="4353450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0kDa</a:t>
            </a:r>
            <a:endParaRPr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F034EC1-4F78-42DE-64D0-20811BB23C9A}"/>
              </a:ext>
            </a:extLst>
          </p:cNvPr>
          <p:cNvSpPr txBox="1"/>
          <p:nvPr/>
        </p:nvSpPr>
        <p:spPr>
          <a:xfrm>
            <a:off x="2310405" y="4885373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kDa</a:t>
            </a:r>
            <a:endParaRPr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9ACC563-9E14-8153-01E9-422B16689BBA}"/>
              </a:ext>
            </a:extLst>
          </p:cNvPr>
          <p:cNvSpPr txBox="1"/>
          <p:nvPr/>
        </p:nvSpPr>
        <p:spPr>
          <a:xfrm>
            <a:off x="2310404" y="5212443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kDa</a:t>
            </a:r>
            <a:endParaRPr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9213208-9445-75D0-11C6-FB59F848E378}"/>
              </a:ext>
            </a:extLst>
          </p:cNvPr>
          <p:cNvSpPr txBox="1"/>
          <p:nvPr/>
        </p:nvSpPr>
        <p:spPr>
          <a:xfrm>
            <a:off x="3711674" y="1277481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 2 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1C87EC9-BA91-FCF7-226E-A4124008DF44}"/>
              </a:ext>
            </a:extLst>
          </p:cNvPr>
          <p:cNvSpPr txBox="1"/>
          <p:nvPr/>
        </p:nvSpPr>
        <p:spPr>
          <a:xfrm>
            <a:off x="2149392" y="1247256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877852A-4399-0F6A-9679-824F0CF1308C}"/>
              </a:ext>
            </a:extLst>
          </p:cNvPr>
          <p:cNvCxnSpPr>
            <a:cxnSpLocks/>
          </p:cNvCxnSpPr>
          <p:nvPr/>
        </p:nvCxnSpPr>
        <p:spPr>
          <a:xfrm flipV="1">
            <a:off x="3835447" y="1217236"/>
            <a:ext cx="5018561" cy="140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08294016-25E4-8827-7D26-F5B772BA585C}"/>
              </a:ext>
            </a:extLst>
          </p:cNvPr>
          <p:cNvSpPr txBox="1"/>
          <p:nvPr/>
        </p:nvSpPr>
        <p:spPr>
          <a:xfrm>
            <a:off x="5133000" y="1282285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 2 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C345708-436D-E025-5885-D79495DD7248}"/>
              </a:ext>
            </a:extLst>
          </p:cNvPr>
          <p:cNvSpPr txBox="1"/>
          <p:nvPr/>
        </p:nvSpPr>
        <p:spPr>
          <a:xfrm>
            <a:off x="6542740" y="1287901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 1 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8566815-E28D-32C0-A70C-6E729E62D16A}"/>
              </a:ext>
            </a:extLst>
          </p:cNvPr>
          <p:cNvSpPr txBox="1"/>
          <p:nvPr/>
        </p:nvSpPr>
        <p:spPr>
          <a:xfrm>
            <a:off x="7787049" y="1249758"/>
            <a:ext cx="2133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73AB063-655F-ABAD-ECA4-3A029C7EBBD3}"/>
              </a:ext>
            </a:extLst>
          </p:cNvPr>
          <p:cNvSpPr txBox="1"/>
          <p:nvPr/>
        </p:nvSpPr>
        <p:spPr>
          <a:xfrm>
            <a:off x="9224676" y="3589919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ITF-Flag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F06FF6D-99CB-BB8B-D519-10DA737F7126}"/>
              </a:ext>
            </a:extLst>
          </p:cNvPr>
          <p:cNvSpPr txBox="1"/>
          <p:nvPr/>
        </p:nvSpPr>
        <p:spPr>
          <a:xfrm>
            <a:off x="9224676" y="4350604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B59C2D7-4178-1A97-FE37-0DB9E010512A}"/>
              </a:ext>
            </a:extLst>
          </p:cNvPr>
          <p:cNvSpPr/>
          <p:nvPr/>
        </p:nvSpPr>
        <p:spPr>
          <a:xfrm>
            <a:off x="5133023" y="823648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FFA166C5-E042-8C23-78E0-550F1AB1125A}"/>
              </a:ext>
            </a:extLst>
          </p:cNvPr>
          <p:cNvSpPr/>
          <p:nvPr/>
        </p:nvSpPr>
        <p:spPr>
          <a:xfrm>
            <a:off x="6589879" y="82926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23B54213-3509-D3D7-5825-207189247474}"/>
              </a:ext>
            </a:extLst>
          </p:cNvPr>
          <p:cNvSpPr/>
          <p:nvPr/>
        </p:nvSpPr>
        <p:spPr>
          <a:xfrm>
            <a:off x="3749107" y="187498"/>
            <a:ext cx="11578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E81D6D3C-8BC7-6C0A-F4BE-FC43CBC3D8FB}"/>
              </a:ext>
            </a:extLst>
          </p:cNvPr>
          <p:cNvSpPr/>
          <p:nvPr/>
        </p:nvSpPr>
        <p:spPr>
          <a:xfrm>
            <a:off x="2136826" y="847904"/>
            <a:ext cx="17928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C0C5714-5CA9-464B-BF69-F4D9E86F2D57}"/>
              </a:ext>
            </a:extLst>
          </p:cNvPr>
          <p:cNvSpPr txBox="1"/>
          <p:nvPr/>
        </p:nvSpPr>
        <p:spPr>
          <a:xfrm>
            <a:off x="2128881" y="479989"/>
            <a:ext cx="10495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A3DD98A-F64E-A8C7-9D02-26E7CB41EFB4}"/>
              </a:ext>
            </a:extLst>
          </p:cNvPr>
          <p:cNvSpPr/>
          <p:nvPr/>
        </p:nvSpPr>
        <p:spPr>
          <a:xfrm>
            <a:off x="3929710" y="875836"/>
            <a:ext cx="739945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0.1                0.1                1             0.1         (24hours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6006F94-ADC2-AB5C-64EE-8539C6501266}"/>
              </a:ext>
            </a:extLst>
          </p:cNvPr>
          <p:cNvSpPr txBox="1"/>
          <p:nvPr/>
        </p:nvSpPr>
        <p:spPr>
          <a:xfrm>
            <a:off x="4229953" y="564706"/>
            <a:ext cx="68288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WT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EV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378B30B-49F2-2CAD-6AB8-83178238A683}"/>
              </a:ext>
            </a:extLst>
          </p:cNvPr>
          <p:cNvSpPr txBox="1"/>
          <p:nvPr/>
        </p:nvSpPr>
        <p:spPr>
          <a:xfrm>
            <a:off x="8021394" y="1279104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CE76846-4379-B62F-8764-F5D6082AE9B6}"/>
              </a:ext>
            </a:extLst>
          </p:cNvPr>
          <p:cNvSpPr/>
          <p:nvPr/>
        </p:nvSpPr>
        <p:spPr>
          <a:xfrm>
            <a:off x="3501484" y="3451301"/>
            <a:ext cx="4560848" cy="14340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AD647132-1AD2-BC98-D5F8-AD8FD0B579D2}"/>
              </a:ext>
            </a:extLst>
          </p:cNvPr>
          <p:cNvSpPr/>
          <p:nvPr/>
        </p:nvSpPr>
        <p:spPr>
          <a:xfrm>
            <a:off x="7992742" y="869238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5877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9A123CA-2104-428C-C9A8-EA048F35B6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0000">
            <a:off x="2743946" y="2275985"/>
            <a:ext cx="6083300" cy="29972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05AE349-E45D-FB76-070E-DA518C77D1EB}"/>
              </a:ext>
            </a:extLst>
          </p:cNvPr>
          <p:cNvSpPr txBox="1"/>
          <p:nvPr/>
        </p:nvSpPr>
        <p:spPr>
          <a:xfrm>
            <a:off x="348343" y="203199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3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5BFD3D7-F003-4314-9414-C9DBC006A613}"/>
              </a:ext>
            </a:extLst>
          </p:cNvPr>
          <p:cNvSpPr txBox="1"/>
          <p:nvPr/>
        </p:nvSpPr>
        <p:spPr>
          <a:xfrm>
            <a:off x="2310407" y="2658245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80kDa</a:t>
            </a:r>
            <a:endParaRPr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FA9594A-44A1-DD08-42B9-86009ACA8041}"/>
              </a:ext>
            </a:extLst>
          </p:cNvPr>
          <p:cNvSpPr txBox="1"/>
          <p:nvPr/>
        </p:nvSpPr>
        <p:spPr>
          <a:xfrm>
            <a:off x="2310407" y="2902139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0kDa</a:t>
            </a:r>
            <a:endParaRPr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4F146E4-E305-9B2C-6782-27B7E4F7CF59}"/>
              </a:ext>
            </a:extLst>
          </p:cNvPr>
          <p:cNvSpPr txBox="1"/>
          <p:nvPr/>
        </p:nvSpPr>
        <p:spPr>
          <a:xfrm>
            <a:off x="2310407" y="3255676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kDa</a:t>
            </a:r>
            <a:endParaRPr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3D36ACD-BA28-DDD4-0CB7-DDDCF9E30DF4}"/>
              </a:ext>
            </a:extLst>
          </p:cNvPr>
          <p:cNvSpPr txBox="1"/>
          <p:nvPr/>
        </p:nvSpPr>
        <p:spPr>
          <a:xfrm>
            <a:off x="2310407" y="3658572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0kDa</a:t>
            </a:r>
            <a:endParaRPr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414653C-8F93-2863-AFF3-0970F689C3BA}"/>
              </a:ext>
            </a:extLst>
          </p:cNvPr>
          <p:cNvSpPr txBox="1"/>
          <p:nvPr/>
        </p:nvSpPr>
        <p:spPr>
          <a:xfrm>
            <a:off x="2310406" y="4075591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5kDa</a:t>
            </a:r>
            <a:endParaRPr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4198C5-BE40-F108-617E-BC627299DCC1}"/>
              </a:ext>
            </a:extLst>
          </p:cNvPr>
          <p:cNvSpPr txBox="1"/>
          <p:nvPr/>
        </p:nvSpPr>
        <p:spPr>
          <a:xfrm>
            <a:off x="2310406" y="4549458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0kDa</a:t>
            </a:r>
            <a:endParaRPr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730D9FD-108D-68B2-BED0-15B0BCAB0BA7}"/>
              </a:ext>
            </a:extLst>
          </p:cNvPr>
          <p:cNvSpPr txBox="1"/>
          <p:nvPr/>
        </p:nvSpPr>
        <p:spPr>
          <a:xfrm>
            <a:off x="2310403" y="4955647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kDa</a:t>
            </a:r>
            <a:endParaRPr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FBB4AB-1141-880D-5532-A7FF94B75FE4}"/>
              </a:ext>
            </a:extLst>
          </p:cNvPr>
          <p:cNvSpPr txBox="1"/>
          <p:nvPr/>
        </p:nvSpPr>
        <p:spPr>
          <a:xfrm>
            <a:off x="3788203" y="2032635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 2 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F0462B0-F3F6-0785-E014-C6B94FF82025}"/>
              </a:ext>
            </a:extLst>
          </p:cNvPr>
          <p:cNvSpPr txBox="1"/>
          <p:nvPr/>
        </p:nvSpPr>
        <p:spPr>
          <a:xfrm>
            <a:off x="2225921" y="2002410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D1D5A77-25B4-F0CB-7CEA-1868D1A1AD42}"/>
              </a:ext>
            </a:extLst>
          </p:cNvPr>
          <p:cNvCxnSpPr>
            <a:cxnSpLocks/>
          </p:cNvCxnSpPr>
          <p:nvPr/>
        </p:nvCxnSpPr>
        <p:spPr>
          <a:xfrm flipV="1">
            <a:off x="3911976" y="1972390"/>
            <a:ext cx="5018561" cy="140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B070B9FB-43EA-DBB4-D3E1-55BB1B61C22E}"/>
              </a:ext>
            </a:extLst>
          </p:cNvPr>
          <p:cNvSpPr txBox="1"/>
          <p:nvPr/>
        </p:nvSpPr>
        <p:spPr>
          <a:xfrm>
            <a:off x="5209529" y="2037439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 2 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4D170E2-6C9C-83DF-3B20-50C6476D1309}"/>
              </a:ext>
            </a:extLst>
          </p:cNvPr>
          <p:cNvSpPr txBox="1"/>
          <p:nvPr/>
        </p:nvSpPr>
        <p:spPr>
          <a:xfrm>
            <a:off x="6619269" y="2043055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 1 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5892739-AEF6-92B1-07F5-B7A1475F4B2C}"/>
              </a:ext>
            </a:extLst>
          </p:cNvPr>
          <p:cNvSpPr txBox="1"/>
          <p:nvPr/>
        </p:nvSpPr>
        <p:spPr>
          <a:xfrm>
            <a:off x="7863578" y="2004912"/>
            <a:ext cx="2133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D3FB41D-47AE-3458-3A08-286C807C2C82}"/>
              </a:ext>
            </a:extLst>
          </p:cNvPr>
          <p:cNvSpPr txBox="1"/>
          <p:nvPr/>
        </p:nvSpPr>
        <p:spPr>
          <a:xfrm>
            <a:off x="8901509" y="3736138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ITF-Flag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9FEF52E-79B5-27DC-7509-62018E5A2472}"/>
              </a:ext>
            </a:extLst>
          </p:cNvPr>
          <p:cNvSpPr txBox="1"/>
          <p:nvPr/>
        </p:nvSpPr>
        <p:spPr>
          <a:xfrm>
            <a:off x="9072136" y="4389471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391E82D-F9AE-1BAB-DE5F-FC4E94572AB9}"/>
              </a:ext>
            </a:extLst>
          </p:cNvPr>
          <p:cNvSpPr/>
          <p:nvPr/>
        </p:nvSpPr>
        <p:spPr>
          <a:xfrm>
            <a:off x="5209552" y="1645708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C5B7BD9-8D58-25E7-4780-8834277848BC}"/>
              </a:ext>
            </a:extLst>
          </p:cNvPr>
          <p:cNvSpPr/>
          <p:nvPr/>
        </p:nvSpPr>
        <p:spPr>
          <a:xfrm>
            <a:off x="6666408" y="165132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D44FA67-5618-A477-34B2-9250686B6822}"/>
              </a:ext>
            </a:extLst>
          </p:cNvPr>
          <p:cNvSpPr/>
          <p:nvPr/>
        </p:nvSpPr>
        <p:spPr>
          <a:xfrm>
            <a:off x="3825636" y="942652"/>
            <a:ext cx="11578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079B93D-9D34-B776-37B7-A0947D64AABC}"/>
              </a:ext>
            </a:extLst>
          </p:cNvPr>
          <p:cNvSpPr/>
          <p:nvPr/>
        </p:nvSpPr>
        <p:spPr>
          <a:xfrm>
            <a:off x="2213355" y="1603058"/>
            <a:ext cx="17928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F79B43A-7B5B-EE53-625A-C7DDEA20A2C9}"/>
              </a:ext>
            </a:extLst>
          </p:cNvPr>
          <p:cNvSpPr txBox="1"/>
          <p:nvPr/>
        </p:nvSpPr>
        <p:spPr>
          <a:xfrm>
            <a:off x="2205410" y="1235143"/>
            <a:ext cx="10495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90C47EA6-7898-34AC-A291-473BE5D085CF}"/>
              </a:ext>
            </a:extLst>
          </p:cNvPr>
          <p:cNvSpPr/>
          <p:nvPr/>
        </p:nvSpPr>
        <p:spPr>
          <a:xfrm>
            <a:off x="4006239" y="1630990"/>
            <a:ext cx="739945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0.1                0.1                1             0.1         (24hours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4F0FDE7-6804-110A-C28B-C7B803BCF9E4}"/>
              </a:ext>
            </a:extLst>
          </p:cNvPr>
          <p:cNvSpPr txBox="1"/>
          <p:nvPr/>
        </p:nvSpPr>
        <p:spPr>
          <a:xfrm>
            <a:off x="4306482" y="1319860"/>
            <a:ext cx="68288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WT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EV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DC6BD96-33D4-5857-E457-35D02262ECDB}"/>
              </a:ext>
            </a:extLst>
          </p:cNvPr>
          <p:cNvSpPr txBox="1"/>
          <p:nvPr/>
        </p:nvSpPr>
        <p:spPr>
          <a:xfrm>
            <a:off x="8097923" y="2019744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FD93A0EC-244D-70D6-70BE-9936603B57B2}"/>
              </a:ext>
            </a:extLst>
          </p:cNvPr>
          <p:cNvSpPr/>
          <p:nvPr/>
        </p:nvSpPr>
        <p:spPr>
          <a:xfrm>
            <a:off x="3501484" y="3451301"/>
            <a:ext cx="4809852" cy="13083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01DDFB45-7DBB-68A1-B9A3-F0944568DC29}"/>
              </a:ext>
            </a:extLst>
          </p:cNvPr>
          <p:cNvSpPr/>
          <p:nvPr/>
        </p:nvSpPr>
        <p:spPr>
          <a:xfrm>
            <a:off x="8046411" y="1609835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18126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EA70FBF-3E4D-1B44-C588-A0E6F10311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39462" y="2231456"/>
            <a:ext cx="5052035" cy="316411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5699BED-76E0-5BC0-8ABE-8E5B827C0B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32454" y="2231456"/>
            <a:ext cx="5052035" cy="316411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D124462-F5FE-64E6-FA7D-F36DA46A5441}"/>
              </a:ext>
            </a:extLst>
          </p:cNvPr>
          <p:cNvSpPr txBox="1"/>
          <p:nvPr/>
        </p:nvSpPr>
        <p:spPr>
          <a:xfrm>
            <a:off x="136297" y="485115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4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76C7663-45DF-1171-809C-88010252851E}"/>
              </a:ext>
            </a:extLst>
          </p:cNvPr>
          <p:cNvSpPr txBox="1"/>
          <p:nvPr/>
        </p:nvSpPr>
        <p:spPr>
          <a:xfrm>
            <a:off x="453981" y="2422272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80kDa</a:t>
            </a:r>
            <a:endParaRPr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ADF7E2D-9002-27C9-AD2E-CBFDFB206DDD}"/>
              </a:ext>
            </a:extLst>
          </p:cNvPr>
          <p:cNvSpPr txBox="1"/>
          <p:nvPr/>
        </p:nvSpPr>
        <p:spPr>
          <a:xfrm>
            <a:off x="453981" y="2666166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0kDa</a:t>
            </a:r>
            <a:endParaRPr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14DD216-FCF5-DF47-27BC-EB948ADEF29E}"/>
              </a:ext>
            </a:extLst>
          </p:cNvPr>
          <p:cNvSpPr txBox="1"/>
          <p:nvPr/>
        </p:nvSpPr>
        <p:spPr>
          <a:xfrm>
            <a:off x="453981" y="3019703"/>
            <a:ext cx="94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kDa</a:t>
            </a:r>
            <a:endParaRPr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0842C1A-6796-29A5-3834-3251AFB0B541}"/>
              </a:ext>
            </a:extLst>
          </p:cNvPr>
          <p:cNvSpPr txBox="1"/>
          <p:nvPr/>
        </p:nvSpPr>
        <p:spPr>
          <a:xfrm>
            <a:off x="453981" y="3321001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0kDa</a:t>
            </a:r>
            <a:endParaRPr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95748B7-68A0-7678-47F5-175821AC2C9E}"/>
              </a:ext>
            </a:extLst>
          </p:cNvPr>
          <p:cNvSpPr txBox="1"/>
          <p:nvPr/>
        </p:nvSpPr>
        <p:spPr>
          <a:xfrm>
            <a:off x="453980" y="3738020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5kDa</a:t>
            </a:r>
            <a:endParaRPr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87EEF40-7C1C-49C4-B30C-D89587A604C4}"/>
              </a:ext>
            </a:extLst>
          </p:cNvPr>
          <p:cNvSpPr txBox="1"/>
          <p:nvPr/>
        </p:nvSpPr>
        <p:spPr>
          <a:xfrm>
            <a:off x="453980" y="4066747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0kDa</a:t>
            </a:r>
            <a:endParaRPr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689356D-10EE-401F-58A5-167356FEE420}"/>
              </a:ext>
            </a:extLst>
          </p:cNvPr>
          <p:cNvSpPr txBox="1"/>
          <p:nvPr/>
        </p:nvSpPr>
        <p:spPr>
          <a:xfrm>
            <a:off x="453977" y="4472936"/>
            <a:ext cx="825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kDa</a:t>
            </a:r>
            <a:endParaRPr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4256DE2-D008-05BB-8216-FBF44F800B0F}"/>
              </a:ext>
            </a:extLst>
          </p:cNvPr>
          <p:cNvSpPr txBox="1"/>
          <p:nvPr/>
        </p:nvSpPr>
        <p:spPr>
          <a:xfrm>
            <a:off x="1481040" y="1792362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6E6FDEC-E46F-8ADE-D4F7-3FF43BBA4763}"/>
              </a:ext>
            </a:extLst>
          </p:cNvPr>
          <p:cNvSpPr txBox="1"/>
          <p:nvPr/>
        </p:nvSpPr>
        <p:spPr>
          <a:xfrm>
            <a:off x="-70184" y="1835552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8C6BCE00-192C-88A3-D65B-CEB2BB2280FE}"/>
              </a:ext>
            </a:extLst>
          </p:cNvPr>
          <p:cNvCxnSpPr>
            <a:cxnSpLocks/>
          </p:cNvCxnSpPr>
          <p:nvPr/>
        </p:nvCxnSpPr>
        <p:spPr>
          <a:xfrm flipV="1">
            <a:off x="1615871" y="1805532"/>
            <a:ext cx="5018561" cy="140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DF835411-8D18-068E-26BF-066D0860CA5B}"/>
              </a:ext>
            </a:extLst>
          </p:cNvPr>
          <p:cNvSpPr txBox="1"/>
          <p:nvPr/>
        </p:nvSpPr>
        <p:spPr>
          <a:xfrm>
            <a:off x="2771740" y="1797166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D0D0F24-648B-21CC-F5C1-6D137B52B6DB}"/>
              </a:ext>
            </a:extLst>
          </p:cNvPr>
          <p:cNvSpPr txBox="1"/>
          <p:nvPr/>
        </p:nvSpPr>
        <p:spPr>
          <a:xfrm>
            <a:off x="4036242" y="1801970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08CFFCC-6309-122D-EE0A-E1B4B8E8E004}"/>
              </a:ext>
            </a:extLst>
          </p:cNvPr>
          <p:cNvSpPr txBox="1"/>
          <p:nvPr/>
        </p:nvSpPr>
        <p:spPr>
          <a:xfrm>
            <a:off x="5567473" y="183805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D1A8A01-D5BD-6BF2-EDEF-71848142847A}"/>
              </a:ext>
            </a:extLst>
          </p:cNvPr>
          <p:cNvSpPr txBox="1"/>
          <p:nvPr/>
        </p:nvSpPr>
        <p:spPr>
          <a:xfrm>
            <a:off x="8522932" y="5551466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ITF-Flag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B23DAFC-C756-C856-76CA-068F803E9BF2}"/>
              </a:ext>
            </a:extLst>
          </p:cNvPr>
          <p:cNvSpPr txBox="1"/>
          <p:nvPr/>
        </p:nvSpPr>
        <p:spPr>
          <a:xfrm>
            <a:off x="2883988" y="543857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AD697DF-5272-9FA3-892E-B65A0A981521}"/>
              </a:ext>
            </a:extLst>
          </p:cNvPr>
          <p:cNvSpPr/>
          <p:nvPr/>
        </p:nvSpPr>
        <p:spPr>
          <a:xfrm>
            <a:off x="2806566" y="1496607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BC87120-2D4A-F185-03C9-11C7A06D44DC}"/>
              </a:ext>
            </a:extLst>
          </p:cNvPr>
          <p:cNvSpPr/>
          <p:nvPr/>
        </p:nvSpPr>
        <p:spPr>
          <a:xfrm>
            <a:off x="4058584" y="1518296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DC74B669-57E9-63DE-6A3D-02AD8FF7E950}"/>
              </a:ext>
            </a:extLst>
          </p:cNvPr>
          <p:cNvSpPr/>
          <p:nvPr/>
        </p:nvSpPr>
        <p:spPr>
          <a:xfrm>
            <a:off x="1529531" y="775794"/>
            <a:ext cx="11578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D9BA36CD-9A92-3C5C-56D0-786317755927}"/>
              </a:ext>
            </a:extLst>
          </p:cNvPr>
          <p:cNvSpPr/>
          <p:nvPr/>
        </p:nvSpPr>
        <p:spPr>
          <a:xfrm>
            <a:off x="-82750" y="1436200"/>
            <a:ext cx="17928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2BB721C-4C66-9446-143C-BE069F9C8F91}"/>
              </a:ext>
            </a:extLst>
          </p:cNvPr>
          <p:cNvSpPr txBox="1"/>
          <p:nvPr/>
        </p:nvSpPr>
        <p:spPr>
          <a:xfrm>
            <a:off x="-90695" y="1068285"/>
            <a:ext cx="10495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26AEF30-523F-7252-A7A7-80737AC05A3B}"/>
              </a:ext>
            </a:extLst>
          </p:cNvPr>
          <p:cNvSpPr/>
          <p:nvPr/>
        </p:nvSpPr>
        <p:spPr>
          <a:xfrm>
            <a:off x="1710134" y="1464132"/>
            <a:ext cx="739945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0.1            0.1                1             0.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D2C66F8-C8D6-01FC-0CED-461C5C006E75}"/>
              </a:ext>
            </a:extLst>
          </p:cNvPr>
          <p:cNvSpPr txBox="1"/>
          <p:nvPr/>
        </p:nvSpPr>
        <p:spPr>
          <a:xfrm>
            <a:off x="2010377" y="1153002"/>
            <a:ext cx="68288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WT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EV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3CEAB26-404C-E789-FB8C-9A833329289D}"/>
              </a:ext>
            </a:extLst>
          </p:cNvPr>
          <p:cNvSpPr txBox="1"/>
          <p:nvPr/>
        </p:nvSpPr>
        <p:spPr>
          <a:xfrm flipH="1">
            <a:off x="5279945" y="1515363"/>
            <a:ext cx="2343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EE5466D-C517-28ED-E7DD-D52BF77E0D99}"/>
              </a:ext>
            </a:extLst>
          </p:cNvPr>
          <p:cNvSpPr/>
          <p:nvPr/>
        </p:nvSpPr>
        <p:spPr>
          <a:xfrm>
            <a:off x="1529531" y="3958656"/>
            <a:ext cx="3798615" cy="565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38389FD6-1BAF-83E0-9E3C-9BD28B44DC8A}"/>
              </a:ext>
            </a:extLst>
          </p:cNvPr>
          <p:cNvSpPr/>
          <p:nvPr/>
        </p:nvSpPr>
        <p:spPr>
          <a:xfrm>
            <a:off x="5300697" y="1483068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091A1BD-047C-DBBC-4908-E170E2D1622C}"/>
              </a:ext>
            </a:extLst>
          </p:cNvPr>
          <p:cNvSpPr txBox="1"/>
          <p:nvPr/>
        </p:nvSpPr>
        <p:spPr>
          <a:xfrm>
            <a:off x="6727192" y="1890894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CE12782-310B-4242-57B1-6B9FC6809454}"/>
              </a:ext>
            </a:extLst>
          </p:cNvPr>
          <p:cNvCxnSpPr>
            <a:cxnSpLocks/>
          </p:cNvCxnSpPr>
          <p:nvPr/>
        </p:nvCxnSpPr>
        <p:spPr>
          <a:xfrm flipV="1">
            <a:off x="6862023" y="1904064"/>
            <a:ext cx="5018561" cy="140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BD8D4C0E-82D1-AC03-C90D-AAD81F6FB6CC}"/>
              </a:ext>
            </a:extLst>
          </p:cNvPr>
          <p:cNvSpPr txBox="1"/>
          <p:nvPr/>
        </p:nvSpPr>
        <p:spPr>
          <a:xfrm>
            <a:off x="8017892" y="189569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6CF8FAB-3C73-75CF-FBB7-F7FCE53FA820}"/>
              </a:ext>
            </a:extLst>
          </p:cNvPr>
          <p:cNvSpPr txBox="1"/>
          <p:nvPr/>
        </p:nvSpPr>
        <p:spPr>
          <a:xfrm>
            <a:off x="9282394" y="1900502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3D07B39-BB38-B1D7-AE6E-996111654238}"/>
              </a:ext>
            </a:extLst>
          </p:cNvPr>
          <p:cNvSpPr txBox="1"/>
          <p:nvPr/>
        </p:nvSpPr>
        <p:spPr>
          <a:xfrm>
            <a:off x="10813625" y="1936586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    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36F00B19-7794-8571-DB4D-BE5D019CB33B}"/>
              </a:ext>
            </a:extLst>
          </p:cNvPr>
          <p:cNvSpPr/>
          <p:nvPr/>
        </p:nvSpPr>
        <p:spPr>
          <a:xfrm>
            <a:off x="8052718" y="1595139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B0B078B6-5EF4-9736-D187-802C14B9C935}"/>
              </a:ext>
            </a:extLst>
          </p:cNvPr>
          <p:cNvSpPr/>
          <p:nvPr/>
        </p:nvSpPr>
        <p:spPr>
          <a:xfrm>
            <a:off x="9304736" y="1616828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49237820-F038-2911-991A-1FF830A32A31}"/>
              </a:ext>
            </a:extLst>
          </p:cNvPr>
          <p:cNvSpPr/>
          <p:nvPr/>
        </p:nvSpPr>
        <p:spPr>
          <a:xfrm>
            <a:off x="6775683" y="874326"/>
            <a:ext cx="11578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6EA25219-9DB0-89F7-535A-0E5BE1845228}"/>
              </a:ext>
            </a:extLst>
          </p:cNvPr>
          <p:cNvSpPr/>
          <p:nvPr/>
        </p:nvSpPr>
        <p:spPr>
          <a:xfrm>
            <a:off x="6956286" y="1562664"/>
            <a:ext cx="739945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0.1            0.1               1            0.1  (24hours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FBB95B5-8D11-5722-1232-62EAE02376C8}"/>
              </a:ext>
            </a:extLst>
          </p:cNvPr>
          <p:cNvSpPr txBox="1"/>
          <p:nvPr/>
        </p:nvSpPr>
        <p:spPr>
          <a:xfrm>
            <a:off x="7256529" y="1251534"/>
            <a:ext cx="68288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WT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EV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C3885C9-1805-D2D1-55FC-8E7888C67F37}"/>
              </a:ext>
            </a:extLst>
          </p:cNvPr>
          <p:cNvSpPr txBox="1"/>
          <p:nvPr/>
        </p:nvSpPr>
        <p:spPr>
          <a:xfrm flipH="1">
            <a:off x="10526097" y="1613895"/>
            <a:ext cx="2343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0DD87731-88CC-6A4E-93A8-949A1259210C}"/>
              </a:ext>
            </a:extLst>
          </p:cNvPr>
          <p:cNvSpPr/>
          <p:nvPr/>
        </p:nvSpPr>
        <p:spPr>
          <a:xfrm>
            <a:off x="10546849" y="1581600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E50DAAF5-F77C-4D5B-C588-CDF600D805B1}"/>
              </a:ext>
            </a:extLst>
          </p:cNvPr>
          <p:cNvSpPr/>
          <p:nvPr/>
        </p:nvSpPr>
        <p:spPr>
          <a:xfrm>
            <a:off x="6644942" y="3202005"/>
            <a:ext cx="3947626" cy="10324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</p:spTree>
    <p:extLst>
      <p:ext uri="{BB962C8B-B14F-4D97-AF65-F5344CB8AC3E}">
        <p14:creationId xmlns:p14="http://schemas.microsoft.com/office/powerpoint/2010/main" val="3745095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267</Words>
  <Application>Microsoft Macintosh PowerPoint</Application>
  <PresentationFormat>Widescreen</PresentationFormat>
  <Paragraphs>9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1</cp:revision>
  <dcterms:created xsi:type="dcterms:W3CDTF">2024-05-15T05:57:51Z</dcterms:created>
  <dcterms:modified xsi:type="dcterms:W3CDTF">2024-05-15T06:40:12Z</dcterms:modified>
</cp:coreProperties>
</file>